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16" userDrawn="1">
          <p15:clr>
            <a:srgbClr val="A4A3A4"/>
          </p15:clr>
        </p15:guide>
        <p15:guide id="2" pos="633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89"/>
    <p:restoredTop sz="94662"/>
  </p:normalViewPr>
  <p:slideViewPr>
    <p:cSldViewPr snapToGrid="0">
      <p:cViewPr varScale="1">
        <p:scale>
          <a:sx n="69" d="100"/>
          <a:sy n="69" d="100"/>
        </p:scale>
        <p:origin x="846" y="78"/>
      </p:cViewPr>
      <p:guideLst>
        <p:guide orient="horz" pos="3816"/>
        <p:guide pos="63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B61E48-F7F0-70C5-F5D1-607CC6F5E4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B51AEF7-2B9C-B533-2B37-E33E7059637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65FFB2F-6208-B8BC-4090-50C0955259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1B84E6-2707-CBC0-6B87-BDDE0E7C89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957BC9-918A-7F86-0C96-10C145A560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00483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97E323-4E31-9804-D66C-8624938D77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0A6A310-DA26-E11F-2419-D04839E486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7EF51E-3FFB-725E-D02C-20F19E4234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397C1C-1047-8EDB-46C3-BCBA74A369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CF366F-CF9F-0428-5F3B-11EF08F33C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11197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7822521-C8B1-B257-60FC-4FA37ED77BB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5C1FD0-BFDD-D9DA-0003-7CEDDEFA68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FDF9DD2-9F02-1E4D-182B-484FC44CED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B1D2BD3-0CE9-73DE-0531-B6129A63BF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EE1E0A0-A459-31B9-6607-9A44727815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56638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B449CD6-7651-DB61-49A9-222808EBB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2BAF6D4-41C4-0844-63F2-04FB0C1229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51AC13-BD8D-C09E-6BA5-0CC10D66F4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EEB924-BACB-3705-CBD7-DD3F0CA31F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CD0A7E-D064-6D01-40A2-7F85FF94CB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7378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F5B1F84-ABF2-B934-D696-41CB8FD4A2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EA4523-E89C-45CD-2254-72D05139D0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6C29A5-D200-2EB6-3968-823589416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D8C5EA-CB6D-9BFC-C122-22C31ABC9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603423-03D5-2AA4-2B97-3F5A5353F9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54665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63D631-737B-797F-0D8E-13C7BB210C9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C15095-5E5E-9EAB-97DE-402D7BA63BE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0D5EC81-AE3C-0FD8-57EB-038AF920BF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EE512D-4167-0178-9FAE-7065127B2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A599DF-B839-10B1-1B3A-3F97B7C042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F9236EA-86B6-7460-933D-B45E2C813B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55458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13D06E-1717-F651-C8FD-A39B2A66C6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3DE6DFD-D177-83E8-D341-82B788121F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842A09-4261-0190-6268-76789D58D1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CD30F56-3EA6-6324-577E-931D1E267AA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70241D7-3DCA-8D37-EC9D-221AF6D656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9F6B84-B812-CF89-87EB-3C97AA056D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36C9D8D0-5F6C-6EAC-AFFF-4951CCC066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16BDBDE-E146-3AA3-8E78-4B2BF3F63D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266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031C80-AC1B-BD61-E9EB-FBDA8B0B81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44943E8-55C1-FB08-9BAF-DF49F15F76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577B32F-DDB9-7BEF-9F96-C3417C891B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361B80D-6985-BBAB-C2A5-8CB1C3EA9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69030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1C3D3C7-3512-79AC-CC57-0EBE84DD05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DBDD743-9822-F4DC-B08A-D489C94C21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5B37BBA-1945-6006-A2F3-B9A5935002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17513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A9C8CE-BEE4-956F-456F-79182A8D7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787383-9AC2-EF7C-2C33-9CDB1EAB01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D1151DE-464B-19B0-71F1-27D418A1D1F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E73BAD-5EB4-481F-88B2-7E4E18293C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7CE456C-7306-84EF-7446-7D9075DA6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F91ADDA-9446-B273-25AE-D6C5B3891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95668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909F04-B086-ED4E-7863-50DF5EBBFD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8509C1C-20A9-F3C5-92EA-6322415CB2E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2E77E26-2873-894E-4980-E29250194A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623E44-38DA-5D70-CB4E-475B2686E0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F18108-CAB5-76FA-0BE9-B09FEA1806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789568-7E70-40E3-0E10-AE88B3E81C5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4841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C40E7AC-354B-143C-C7BB-EEA9DB5E3C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0B8C059-2423-2DEA-6DC6-692826CE0F7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5B0DC0-1036-4CC5-19E5-694D9C73707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D1F1F8-3046-A640-AFD5-808D1865F353}" type="datetimeFigureOut">
              <a:rPr lang="en-US" smtClean="0"/>
              <a:t>8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1E1554-49AA-59C5-53F4-B3AB76325AB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6F394F-2084-AB5D-E6DB-76407E963C3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54938D-B591-5F40-B37F-D15993DFD9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800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群組 1"/>
          <p:cNvGrpSpPr/>
          <p:nvPr/>
        </p:nvGrpSpPr>
        <p:grpSpPr>
          <a:xfrm>
            <a:off x="682270" y="1192103"/>
            <a:ext cx="5301140" cy="4156100"/>
            <a:chOff x="3377639" y="869829"/>
            <a:chExt cx="5301140" cy="4156100"/>
          </a:xfrm>
        </p:grpSpPr>
        <p:pic>
          <p:nvPicPr>
            <p:cNvPr id="3" name="圖片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77639" y="1233906"/>
              <a:ext cx="5301140" cy="3032433"/>
            </a:xfrm>
            <a:prstGeom prst="rect">
              <a:avLst/>
            </a:prstGeom>
          </p:spPr>
        </p:pic>
        <p:sp>
          <p:nvSpPr>
            <p:cNvPr id="4" name="文字方塊 3"/>
            <p:cNvSpPr txBox="1"/>
            <p:nvPr/>
          </p:nvSpPr>
          <p:spPr>
            <a:xfrm>
              <a:off x="6352116" y="911394"/>
              <a:ext cx="3561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文字方塊 4"/>
            <p:cNvSpPr txBox="1"/>
            <p:nvPr/>
          </p:nvSpPr>
          <p:spPr>
            <a:xfrm>
              <a:off x="5311290" y="911394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文字方塊 5"/>
            <p:cNvSpPr txBox="1"/>
            <p:nvPr/>
          </p:nvSpPr>
          <p:spPr>
            <a:xfrm>
              <a:off x="5590111" y="911394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文字方塊 6"/>
            <p:cNvSpPr txBox="1"/>
            <p:nvPr/>
          </p:nvSpPr>
          <p:spPr>
            <a:xfrm>
              <a:off x="5858369" y="911394"/>
              <a:ext cx="29848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文字方塊 7"/>
            <p:cNvSpPr txBox="1"/>
            <p:nvPr/>
          </p:nvSpPr>
          <p:spPr>
            <a:xfrm>
              <a:off x="5050777" y="911394"/>
              <a:ext cx="35618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600" dirty="0">
                  <a:latin typeface="Arial" panose="020B0604020202020204" pitchFamily="34" charset="0"/>
                  <a:cs typeface="Arial" panose="020B0604020202020204" pitchFamily="34" charset="0"/>
                </a:rPr>
                <a:t>M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文字方塊 8"/>
            <p:cNvSpPr txBox="1"/>
            <p:nvPr/>
          </p:nvSpPr>
          <p:spPr>
            <a:xfrm>
              <a:off x="6114915" y="911394"/>
              <a:ext cx="25359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sz="160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zh-TW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文字方塊 9"/>
            <p:cNvSpPr txBox="1"/>
            <p:nvPr/>
          </p:nvSpPr>
          <p:spPr>
            <a:xfrm>
              <a:off x="4702081" y="4271764"/>
              <a:ext cx="6227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Calibri" panose="020F0502020204030204" pitchFamily="34" charset="0"/>
                  <a:cs typeface="Calibri" panose="020F0502020204030204" pitchFamily="34" charset="0"/>
                </a:rPr>
                <a:t>GTP:</a:t>
              </a:r>
              <a:endParaRPr lang="zh-TW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1" name="文字方塊 10"/>
            <p:cNvSpPr txBox="1"/>
            <p:nvPr/>
          </p:nvSpPr>
          <p:spPr>
            <a:xfrm>
              <a:off x="4293315" y="4656597"/>
              <a:ext cx="10150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latin typeface="Calibri" panose="020F0502020204030204" pitchFamily="34" charset="0"/>
                  <a:cs typeface="Calibri" panose="020F0502020204030204" pitchFamily="34" charset="0"/>
                </a:rPr>
                <a:t>RNase R:</a:t>
              </a:r>
              <a:endParaRPr lang="zh-TW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2" name="文字方塊 11"/>
            <p:cNvSpPr txBox="1"/>
            <p:nvPr/>
          </p:nvSpPr>
          <p:spPr>
            <a:xfrm>
              <a:off x="5329725" y="4286442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-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3" name="文字方塊 12"/>
            <p:cNvSpPr txBox="1"/>
            <p:nvPr/>
          </p:nvSpPr>
          <p:spPr>
            <a:xfrm>
              <a:off x="5329725" y="4620886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-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4" name="文字方塊 13"/>
            <p:cNvSpPr txBox="1"/>
            <p:nvPr/>
          </p:nvSpPr>
          <p:spPr>
            <a:xfrm>
              <a:off x="5608546" y="4620886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-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5" name="文字方塊 14"/>
            <p:cNvSpPr txBox="1"/>
            <p:nvPr/>
          </p:nvSpPr>
          <p:spPr>
            <a:xfrm>
              <a:off x="5857568" y="428644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6" name="文字方塊 15"/>
            <p:cNvSpPr txBox="1"/>
            <p:nvPr/>
          </p:nvSpPr>
          <p:spPr>
            <a:xfrm>
              <a:off x="5589310" y="4286442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7" name="文字方塊 16"/>
            <p:cNvSpPr txBox="1"/>
            <p:nvPr/>
          </p:nvSpPr>
          <p:spPr>
            <a:xfrm>
              <a:off x="5857568" y="4638330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18" name="矩形 17"/>
            <p:cNvSpPr/>
            <p:nvPr/>
          </p:nvSpPr>
          <p:spPr>
            <a:xfrm>
              <a:off x="5050777" y="869829"/>
              <a:ext cx="1116491" cy="3372389"/>
            </a:xfrm>
            <a:prstGeom prst="rect">
              <a:avLst/>
            </a:prstGeom>
            <a:noFill/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</p:grpSp>
      <p:pic>
        <p:nvPicPr>
          <p:cNvPr id="19" name="Picture 8">
            <a:extLst>
              <a:ext uri="{FF2B5EF4-FFF2-40B4-BE49-F238E27FC236}">
                <a16:creationId xmlns:a16="http://schemas.microsoft.com/office/drawing/2014/main" id="{854DA01C-9C45-16A2-7BD8-7376E2E2135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2814" y="1556180"/>
            <a:ext cx="5397596" cy="3196924"/>
          </a:xfrm>
          <a:prstGeom prst="rect">
            <a:avLst/>
          </a:prstGeom>
        </p:spPr>
      </p:pic>
      <p:sp>
        <p:nvSpPr>
          <p:cNvPr id="20" name="文字方塊 19"/>
          <p:cNvSpPr txBox="1"/>
          <p:nvPr/>
        </p:nvSpPr>
        <p:spPr>
          <a:xfrm>
            <a:off x="9375761" y="1325908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8202586" y="132590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字方塊 21"/>
          <p:cNvSpPr txBox="1"/>
          <p:nvPr/>
        </p:nvSpPr>
        <p:spPr>
          <a:xfrm>
            <a:off x="8529534" y="132590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8809825" y="132590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字方塊 23"/>
          <p:cNvSpPr txBox="1"/>
          <p:nvPr/>
        </p:nvSpPr>
        <p:spPr>
          <a:xfrm>
            <a:off x="7881915" y="1325908"/>
            <a:ext cx="35618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600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字方塊 24"/>
          <p:cNvSpPr txBox="1"/>
          <p:nvPr/>
        </p:nvSpPr>
        <p:spPr>
          <a:xfrm>
            <a:off x="9066370" y="132590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zh-TW" sz="160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zh-TW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群組 39"/>
          <p:cNvGrpSpPr/>
          <p:nvPr/>
        </p:nvGrpSpPr>
        <p:grpSpPr>
          <a:xfrm>
            <a:off x="7145775" y="4614087"/>
            <a:ext cx="1963333" cy="754165"/>
            <a:chOff x="7145775" y="4614087"/>
            <a:chExt cx="1963333" cy="754165"/>
          </a:xfrm>
        </p:grpSpPr>
        <p:sp>
          <p:nvSpPr>
            <p:cNvPr id="26" name="文字方塊 25"/>
            <p:cNvSpPr txBox="1"/>
            <p:nvPr/>
          </p:nvSpPr>
          <p:spPr>
            <a:xfrm>
              <a:off x="7554541" y="4614087"/>
              <a:ext cx="62273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TW" dirty="0">
                  <a:latin typeface="Calibri" panose="020F0502020204030204" pitchFamily="34" charset="0"/>
                  <a:cs typeface="Calibri" panose="020F0502020204030204" pitchFamily="34" charset="0"/>
                </a:rPr>
                <a:t>GTP:</a:t>
              </a:r>
              <a:endParaRPr lang="zh-TW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7" name="文字方塊 26"/>
            <p:cNvSpPr txBox="1"/>
            <p:nvPr/>
          </p:nvSpPr>
          <p:spPr>
            <a:xfrm>
              <a:off x="7145775" y="4998920"/>
              <a:ext cx="101502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dirty="0">
                  <a:latin typeface="Calibri" panose="020F0502020204030204" pitchFamily="34" charset="0"/>
                  <a:cs typeface="Calibri" panose="020F0502020204030204" pitchFamily="34" charset="0"/>
                </a:rPr>
                <a:t>RNase R:</a:t>
              </a:r>
              <a:endParaRPr lang="zh-TW" altLang="en-US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8" name="文字方塊 27"/>
            <p:cNvSpPr txBox="1"/>
            <p:nvPr/>
          </p:nvSpPr>
          <p:spPr>
            <a:xfrm>
              <a:off x="8221023" y="4628765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-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9" name="文字方塊 28"/>
            <p:cNvSpPr txBox="1"/>
            <p:nvPr/>
          </p:nvSpPr>
          <p:spPr>
            <a:xfrm>
              <a:off x="8221023" y="496320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-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0" name="文字方塊 29"/>
            <p:cNvSpPr txBox="1"/>
            <p:nvPr/>
          </p:nvSpPr>
          <p:spPr>
            <a:xfrm>
              <a:off x="8535940" y="4963209"/>
              <a:ext cx="26161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-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1" name="文字方塊 30"/>
            <p:cNvSpPr txBox="1"/>
            <p:nvPr/>
          </p:nvSpPr>
          <p:spPr>
            <a:xfrm>
              <a:off x="8809026" y="462876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2" name="文字方塊 31"/>
            <p:cNvSpPr txBox="1"/>
            <p:nvPr/>
          </p:nvSpPr>
          <p:spPr>
            <a:xfrm>
              <a:off x="8516704" y="4628765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33" name="文字方塊 32"/>
            <p:cNvSpPr txBox="1"/>
            <p:nvPr/>
          </p:nvSpPr>
          <p:spPr>
            <a:xfrm>
              <a:off x="8809026" y="4980653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zh-TW" b="1" dirty="0">
                  <a:latin typeface="Calibri" panose="020F0502020204030204" pitchFamily="34" charset="0"/>
                  <a:cs typeface="Calibri" panose="020F0502020204030204" pitchFamily="34" charset="0"/>
                </a:rPr>
                <a:t>+</a:t>
              </a:r>
              <a:endParaRPr lang="zh-TW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34" name="矩形 33"/>
          <p:cNvSpPr/>
          <p:nvPr/>
        </p:nvSpPr>
        <p:spPr>
          <a:xfrm>
            <a:off x="7893947" y="1310363"/>
            <a:ext cx="1224779" cy="329835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7" name="文字方塊 36"/>
          <p:cNvSpPr txBox="1"/>
          <p:nvPr/>
        </p:nvSpPr>
        <p:spPr>
          <a:xfrm>
            <a:off x="4512398" y="235682"/>
            <a:ext cx="38319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altLang="zh-TW" dirty="0" smtClean="0"/>
              <a:t>Supplementary </a:t>
            </a:r>
            <a:r>
              <a:rPr lang="fr-FR" altLang="zh-TW" dirty="0"/>
              <a:t>file 3. Suppl. Figure S1.</a:t>
            </a:r>
            <a:endParaRPr lang="zh-TW" altLang="en-US" dirty="0"/>
          </a:p>
        </p:txBody>
      </p:sp>
      <p:sp>
        <p:nvSpPr>
          <p:cNvPr id="38" name="TextBox 18">
            <a:extLst>
              <a:ext uri="{FF2B5EF4-FFF2-40B4-BE49-F238E27FC236}">
                <a16:creationId xmlns:a16="http://schemas.microsoft.com/office/drawing/2014/main" id="{AA4E64DC-6C32-5644-E10C-A805F1B29E2C}"/>
              </a:ext>
            </a:extLst>
          </p:cNvPr>
          <p:cNvSpPr txBox="1"/>
          <p:nvPr/>
        </p:nvSpPr>
        <p:spPr>
          <a:xfrm>
            <a:off x="630327" y="5436454"/>
            <a:ext cx="10706166" cy="120032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iginal and uncropped RNA gel electrophoresis image of Figure 2A (left panel). The right panel shows the black/white-inverted gel image; the part of the gel shown in Figure 2A is boxed in red. Lane M: RNA ladder; lane 1: untreated precursor RNA; lane 2: GTP-treated RNA; lane 3: GTP- and RNase R-treated RNA. 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CCA10068-700B-3097-E40E-09520DD1B41C}"/>
              </a:ext>
            </a:extLst>
          </p:cNvPr>
          <p:cNvSpPr txBox="1"/>
          <p:nvPr/>
        </p:nvSpPr>
        <p:spPr>
          <a:xfrm>
            <a:off x="2055676" y="761576"/>
            <a:ext cx="1868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u="sng" dirty="0"/>
              <a:t>Original gel image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E9B6970E-19F8-842D-7169-8278BDFD2E16}"/>
              </a:ext>
            </a:extLst>
          </p:cNvPr>
          <p:cNvSpPr txBox="1"/>
          <p:nvPr/>
        </p:nvSpPr>
        <p:spPr>
          <a:xfrm>
            <a:off x="7514386" y="882291"/>
            <a:ext cx="27508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u="sng" dirty="0"/>
              <a:t>Black/white inverted image</a:t>
            </a:r>
          </a:p>
        </p:txBody>
      </p:sp>
    </p:spTree>
    <p:extLst>
      <p:ext uri="{BB962C8B-B14F-4D97-AF65-F5344CB8AC3E}">
        <p14:creationId xmlns:p14="http://schemas.microsoft.com/office/powerpoint/2010/main" val="34398901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3</TotalTime>
  <Words>118</Words>
  <Application>Microsoft Office PowerPoint</Application>
  <PresentationFormat>寬螢幕</PresentationFormat>
  <Paragraphs>32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新細明體</vt:lpstr>
      <vt:lpstr>Arial</vt:lpstr>
      <vt:lpstr>Calibri</vt:lpstr>
      <vt:lpstr>Calibri Light</vt:lpstr>
      <vt:lpstr>Times New Roman</vt:lpstr>
      <vt:lpstr>Office Theme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NA blot</dc:title>
  <dc:creator>Alan R</dc:creator>
  <cp:lastModifiedBy>黃秋容</cp:lastModifiedBy>
  <cp:revision>22</cp:revision>
  <dcterms:created xsi:type="dcterms:W3CDTF">2023-07-31T14:48:22Z</dcterms:created>
  <dcterms:modified xsi:type="dcterms:W3CDTF">2023-08-26T08:31:12Z</dcterms:modified>
</cp:coreProperties>
</file>